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84C61B-260A-4261-962E-FA886F9DD12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96700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C9590A-0DE0-4E00-82A9-49C172AA6F2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1241D8-ECE1-4D6F-A068-68A5FBDD1A1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0B46E5-625D-4DFE-8DF1-9A49F38ABB7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B5D9D8-F133-44CC-BEDD-0EB6F25FEE1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453A65-F41C-43DD-8EB9-2461DA556BF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EA66BB-080D-4872-B7AF-9AD5B1CE6D6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863BAB-1A70-46C2-93F1-B291E5CBB75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80560"/>
            <a:ext cx="582912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215922-05A8-4CB4-BC81-9E2DBF4A470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964E68-8C99-4D6D-A624-5517178FB97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15CC61-92FB-4453-94A1-02793650251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782F9C-C60B-4F66-8C97-B68CD4CEC2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9024480"/>
            <a:ext cx="142884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4480"/>
            <a:ext cx="217152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9024480"/>
            <a:ext cx="142848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B563FEF-8085-4796-ACF0-824D3F70ADCE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574560" y="662040"/>
            <a:ext cx="5715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</a:rPr>
              <a:t>Supplementary figure S2.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 EBER1 expression in the non-lymphoid tissues of the EµEBER1 transgenic lines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669960" y="1415880"/>
            <a:ext cx="5526000" cy="5578560"/>
            <a:chOff x="669960" y="1415880"/>
            <a:chExt cx="5526000" cy="5578560"/>
          </a:xfrm>
        </p:grpSpPr>
        <p:grpSp>
          <p:nvGrpSpPr>
            <p:cNvPr id="43" name=""/>
            <p:cNvGrpSpPr/>
            <p:nvPr/>
          </p:nvGrpSpPr>
          <p:grpSpPr>
            <a:xfrm>
              <a:off x="761400" y="1510920"/>
              <a:ext cx="5326200" cy="5280120"/>
              <a:chOff x="761400" y="1510920"/>
              <a:chExt cx="5326200" cy="5280120"/>
            </a:xfrm>
          </p:grpSpPr>
          <p:sp>
            <p:nvSpPr>
              <p:cNvPr id="44" name=""/>
              <p:cNvSpPr/>
              <p:nvPr/>
            </p:nvSpPr>
            <p:spPr>
              <a:xfrm>
                <a:off x="1193760" y="1654920"/>
                <a:ext cx="696600" cy="273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stomach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5" name=""/>
              <p:cNvSpPr/>
              <p:nvPr/>
            </p:nvSpPr>
            <p:spPr>
              <a:xfrm>
                <a:off x="805680" y="2015640"/>
                <a:ext cx="411480" cy="273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396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6" name=""/>
              <p:cNvSpPr/>
              <p:nvPr/>
            </p:nvSpPr>
            <p:spPr>
              <a:xfrm>
                <a:off x="805680" y="2348640"/>
                <a:ext cx="411480" cy="273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154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881640" y="1664640"/>
                <a:ext cx="335520" cy="273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bp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pic>
            <p:nvPicPr>
              <p:cNvPr id="48" name="" descr=""/>
              <p:cNvPicPr/>
              <p:nvPr/>
            </p:nvPicPr>
            <p:blipFill>
              <a:blip r:embed="rId1"/>
              <a:srcRect l="0" t="5748" r="0" b="10353"/>
              <a:stretch/>
            </p:blipFill>
            <p:spPr>
              <a:xfrm>
                <a:off x="1307880" y="2072880"/>
                <a:ext cx="4637160" cy="6937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9" name=""/>
              <p:cNvSpPr/>
              <p:nvPr/>
            </p:nvSpPr>
            <p:spPr>
              <a:xfrm>
                <a:off x="1123920" y="2500560"/>
                <a:ext cx="151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1123920" y="2319840"/>
                <a:ext cx="151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1123920" y="2167920"/>
                <a:ext cx="151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1301400" y="1825560"/>
                <a:ext cx="4054680" cy="273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+    -   +    -   +   -  +    -   +   -   +    -   +    -   +   -   +    -   +    -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1716120" y="1654920"/>
                <a:ext cx="487440" cy="273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lung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>
                <a:off x="2067840" y="1654920"/>
                <a:ext cx="487440" cy="273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heart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2438640" y="1654920"/>
                <a:ext cx="487440" cy="273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S.int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>
                <a:off x="3129120" y="1654920"/>
                <a:ext cx="639360" cy="273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ovaries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3575880" y="1654920"/>
                <a:ext cx="639720" cy="273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uterus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>
                <a:off x="4377240" y="1654920"/>
                <a:ext cx="639360" cy="273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oesp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4725720" y="1654920"/>
                <a:ext cx="639360" cy="273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trachea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2771280" y="1656360"/>
                <a:ext cx="532080" cy="273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testis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4060440" y="1656360"/>
                <a:ext cx="639360" cy="273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kid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>
                <a:off x="805680" y="2187000"/>
                <a:ext cx="411480" cy="273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220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1307880" y="2072880"/>
                <a:ext cx="4656240" cy="69372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>
                <a:off x="1402560" y="1882800"/>
                <a:ext cx="275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>
                <a:off x="1782720" y="1882800"/>
                <a:ext cx="275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2163240" y="1882800"/>
                <a:ext cx="275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>
                <a:off x="2533680" y="1882800"/>
                <a:ext cx="275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>
                <a:off x="2885400" y="1882800"/>
                <a:ext cx="275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3274560" y="1882800"/>
                <a:ext cx="275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3683520" y="1882800"/>
                <a:ext cx="275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4073040" y="1882800"/>
                <a:ext cx="275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4472280" y="1882800"/>
                <a:ext cx="275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4852440" y="1882800"/>
                <a:ext cx="275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761400" y="1510920"/>
                <a:ext cx="7444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Line 136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1336320" y="2994840"/>
                <a:ext cx="456120" cy="272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brain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>
                <a:off x="1860480" y="2991600"/>
                <a:ext cx="416160" cy="272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SG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>
                <a:off x="2210400" y="2991600"/>
                <a:ext cx="649080" cy="272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tongue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2738160" y="2993040"/>
                <a:ext cx="479520" cy="273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NPR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>
                <a:off x="3137040" y="2991600"/>
                <a:ext cx="631440" cy="27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muscle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>
                <a:off x="3616920" y="2994840"/>
                <a:ext cx="456120" cy="272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ears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>
                <a:off x="805680" y="3474720"/>
                <a:ext cx="411480" cy="273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396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>
                <a:off x="805680" y="3754800"/>
                <a:ext cx="411480" cy="273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154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>
                <a:off x="881640" y="3162600"/>
                <a:ext cx="335520" cy="273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bp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>
                <a:off x="1123920" y="3857760"/>
                <a:ext cx="151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>
                <a:off x="1123920" y="3753360"/>
                <a:ext cx="151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>
                <a:off x="1123920" y="3610800"/>
                <a:ext cx="151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>
                <a:off x="1123920" y="3477960"/>
                <a:ext cx="151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8" name=""/>
              <p:cNvSpPr/>
              <p:nvPr/>
            </p:nvSpPr>
            <p:spPr>
              <a:xfrm>
                <a:off x="805680" y="3606120"/>
                <a:ext cx="411480" cy="273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220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>
                <a:off x="805680" y="3336840"/>
                <a:ext cx="411480" cy="273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506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pic>
            <p:nvPicPr>
              <p:cNvPr id="90" name="" descr=""/>
              <p:cNvPicPr/>
              <p:nvPr/>
            </p:nvPicPr>
            <p:blipFill>
              <a:blip r:embed="rId2"/>
              <a:srcRect l="0" t="10766" r="0" b="0"/>
              <a:stretch/>
            </p:blipFill>
            <p:spPr>
              <a:xfrm>
                <a:off x="1317240" y="3419280"/>
                <a:ext cx="3288240" cy="6300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1" name=""/>
              <p:cNvSpPr/>
              <p:nvPr/>
            </p:nvSpPr>
            <p:spPr>
              <a:xfrm>
                <a:off x="1317240" y="3419280"/>
                <a:ext cx="3269160" cy="6080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>
                <a:off x="1281600" y="3183120"/>
                <a:ext cx="28508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 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+     -     +     -     +      -     +      -     +     -     +     -   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1431360" y="3200760"/>
                <a:ext cx="275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>
                <a:off x="1906200" y="3200760"/>
                <a:ext cx="275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>
                <a:off x="2352960" y="3200760"/>
                <a:ext cx="275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>
                <a:off x="2809080" y="3200760"/>
                <a:ext cx="275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7" name=""/>
              <p:cNvSpPr/>
              <p:nvPr/>
            </p:nvSpPr>
            <p:spPr>
              <a:xfrm>
                <a:off x="3246480" y="3200760"/>
                <a:ext cx="275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>
                <a:off x="3683520" y="3200760"/>
                <a:ext cx="275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>
                <a:off x="761400" y="2850480"/>
                <a:ext cx="7444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Line 127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>
                <a:off x="1325160" y="4484880"/>
                <a:ext cx="3786840" cy="273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+    -    +     -    +    -    +     -   +     -    +    -    +    -    +    -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>
                <a:off x="2419560" y="4287240"/>
                <a:ext cx="684000" cy="243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trachea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>
                <a:off x="3173400" y="4287240"/>
                <a:ext cx="728640" cy="243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muscle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3" name=""/>
              <p:cNvSpPr/>
              <p:nvPr/>
            </p:nvSpPr>
            <p:spPr>
              <a:xfrm>
                <a:off x="2837520" y="4284000"/>
                <a:ext cx="608400" cy="243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oesp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4" name=""/>
              <p:cNvSpPr/>
              <p:nvPr/>
            </p:nvSpPr>
            <p:spPr>
              <a:xfrm>
                <a:off x="3624840" y="4287240"/>
                <a:ext cx="429120" cy="243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kid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>
                <a:off x="1201680" y="4287240"/>
                <a:ext cx="790200" cy="243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stomach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6" name=""/>
              <p:cNvSpPr/>
              <p:nvPr/>
            </p:nvSpPr>
            <p:spPr>
              <a:xfrm>
                <a:off x="1716120" y="4287240"/>
                <a:ext cx="427680" cy="243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lung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7" name=""/>
              <p:cNvSpPr/>
              <p:nvPr/>
            </p:nvSpPr>
            <p:spPr>
              <a:xfrm>
                <a:off x="1982520" y="4282560"/>
                <a:ext cx="626760" cy="324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S.int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pic>
            <p:nvPicPr>
              <p:cNvPr id="108" name="" descr=""/>
              <p:cNvPicPr/>
              <p:nvPr/>
            </p:nvPicPr>
            <p:blipFill>
              <a:blip r:embed="rId3"/>
              <a:srcRect l="0" t="19434" r="0" b="0"/>
              <a:stretch/>
            </p:blipFill>
            <p:spPr>
              <a:xfrm>
                <a:off x="1307880" y="4711680"/>
                <a:ext cx="3496680" cy="669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09" name="" descr=""/>
              <p:cNvPicPr/>
              <p:nvPr/>
            </p:nvPicPr>
            <p:blipFill>
              <a:blip r:embed="rId4"/>
              <a:stretch/>
            </p:blipFill>
            <p:spPr>
              <a:xfrm>
                <a:off x="1317240" y="5238720"/>
                <a:ext cx="465480" cy="1472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10" name=""/>
              <p:cNvSpPr/>
              <p:nvPr/>
            </p:nvSpPr>
            <p:spPr>
              <a:xfrm>
                <a:off x="805680" y="4580280"/>
                <a:ext cx="411480" cy="273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506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>
                <a:off x="805680" y="4719600"/>
                <a:ext cx="411480" cy="273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396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>
                <a:off x="805680" y="4860360"/>
                <a:ext cx="411480" cy="273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220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3" name=""/>
              <p:cNvSpPr/>
              <p:nvPr/>
            </p:nvSpPr>
            <p:spPr>
              <a:xfrm>
                <a:off x="805680" y="4999680"/>
                <a:ext cx="411480" cy="273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154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>
                <a:off x="881640" y="4369320"/>
                <a:ext cx="335520" cy="273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bp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5" name=""/>
              <p:cNvSpPr/>
              <p:nvPr/>
            </p:nvSpPr>
            <p:spPr>
              <a:xfrm>
                <a:off x="3968640" y="4287240"/>
                <a:ext cx="465480" cy="243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heart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6" name=""/>
              <p:cNvSpPr/>
              <p:nvPr/>
            </p:nvSpPr>
            <p:spPr>
              <a:xfrm>
                <a:off x="5147280" y="4484880"/>
                <a:ext cx="883440" cy="273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+    -    +     -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>
                <a:off x="5067720" y="4293720"/>
                <a:ext cx="657000" cy="273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ovaries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8" name=""/>
              <p:cNvSpPr/>
              <p:nvPr/>
            </p:nvSpPr>
            <p:spPr>
              <a:xfrm>
                <a:off x="5498640" y="4293720"/>
                <a:ext cx="588960" cy="273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uterus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pic>
            <p:nvPicPr>
              <p:cNvPr id="119" name="" descr=""/>
              <p:cNvPicPr/>
              <p:nvPr/>
            </p:nvPicPr>
            <p:blipFill>
              <a:blip r:embed="rId5"/>
              <a:stretch/>
            </p:blipFill>
            <p:spPr>
              <a:xfrm>
                <a:off x="5118480" y="4711680"/>
                <a:ext cx="912240" cy="6742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20" name=""/>
              <p:cNvSpPr/>
              <p:nvPr/>
            </p:nvSpPr>
            <p:spPr>
              <a:xfrm>
                <a:off x="1412280" y="4502520"/>
                <a:ext cx="275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1" name=""/>
              <p:cNvSpPr/>
              <p:nvPr/>
            </p:nvSpPr>
            <p:spPr>
              <a:xfrm>
                <a:off x="1792440" y="4502520"/>
                <a:ext cx="275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2" name=""/>
              <p:cNvSpPr/>
              <p:nvPr/>
            </p:nvSpPr>
            <p:spPr>
              <a:xfrm>
                <a:off x="2172240" y="4502520"/>
                <a:ext cx="275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3" name=""/>
              <p:cNvSpPr/>
              <p:nvPr/>
            </p:nvSpPr>
            <p:spPr>
              <a:xfrm>
                <a:off x="2552760" y="4502520"/>
                <a:ext cx="275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4" name=""/>
              <p:cNvSpPr/>
              <p:nvPr/>
            </p:nvSpPr>
            <p:spPr>
              <a:xfrm>
                <a:off x="2904480" y="4502520"/>
                <a:ext cx="275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5" name=""/>
              <p:cNvSpPr/>
              <p:nvPr/>
            </p:nvSpPr>
            <p:spPr>
              <a:xfrm>
                <a:off x="3284280" y="4502520"/>
                <a:ext cx="275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6" name=""/>
              <p:cNvSpPr/>
              <p:nvPr/>
            </p:nvSpPr>
            <p:spPr>
              <a:xfrm>
                <a:off x="3664440" y="4502520"/>
                <a:ext cx="275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7" name=""/>
              <p:cNvSpPr/>
              <p:nvPr/>
            </p:nvSpPr>
            <p:spPr>
              <a:xfrm>
                <a:off x="4044960" y="4502520"/>
                <a:ext cx="275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8" name=""/>
              <p:cNvSpPr/>
              <p:nvPr/>
            </p:nvSpPr>
            <p:spPr>
              <a:xfrm>
                <a:off x="1317240" y="4701960"/>
                <a:ext cx="3487320" cy="674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9" name=""/>
              <p:cNvSpPr/>
              <p:nvPr/>
            </p:nvSpPr>
            <p:spPr>
              <a:xfrm>
                <a:off x="5118480" y="4701960"/>
                <a:ext cx="912240" cy="68400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0" name=""/>
              <p:cNvSpPr/>
              <p:nvPr/>
            </p:nvSpPr>
            <p:spPr>
              <a:xfrm>
                <a:off x="5222880" y="4502520"/>
                <a:ext cx="275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1" name=""/>
              <p:cNvSpPr/>
              <p:nvPr/>
            </p:nvSpPr>
            <p:spPr>
              <a:xfrm>
                <a:off x="5603400" y="4502520"/>
                <a:ext cx="275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>
                <a:off x="761400" y="4125600"/>
                <a:ext cx="7444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Line 131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3" name=""/>
              <p:cNvSpPr/>
              <p:nvPr/>
            </p:nvSpPr>
            <p:spPr>
              <a:xfrm>
                <a:off x="807120" y="6004080"/>
                <a:ext cx="410040" cy="273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506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4" name=""/>
              <p:cNvSpPr/>
              <p:nvPr/>
            </p:nvSpPr>
            <p:spPr>
              <a:xfrm>
                <a:off x="807120" y="6143400"/>
                <a:ext cx="410040" cy="273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396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5" name=""/>
              <p:cNvSpPr/>
              <p:nvPr/>
            </p:nvSpPr>
            <p:spPr>
              <a:xfrm>
                <a:off x="807120" y="6284520"/>
                <a:ext cx="410040" cy="273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220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6" name=""/>
              <p:cNvSpPr/>
              <p:nvPr/>
            </p:nvSpPr>
            <p:spPr>
              <a:xfrm>
                <a:off x="807120" y="6423840"/>
                <a:ext cx="410040" cy="273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154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7" name=""/>
              <p:cNvSpPr/>
              <p:nvPr/>
            </p:nvSpPr>
            <p:spPr>
              <a:xfrm>
                <a:off x="881640" y="5793480"/>
                <a:ext cx="335520" cy="273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bp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8" name=""/>
              <p:cNvSpPr/>
              <p:nvPr/>
            </p:nvSpPr>
            <p:spPr>
              <a:xfrm>
                <a:off x="1290240" y="5870880"/>
                <a:ext cx="3780360" cy="273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+     -    +    -     +    -    +    -     +    -    +     -    +    -     +    -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9" name=""/>
              <p:cNvSpPr/>
              <p:nvPr/>
            </p:nvSpPr>
            <p:spPr>
              <a:xfrm>
                <a:off x="2408400" y="5677920"/>
                <a:ext cx="514440" cy="352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S.int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0" name=""/>
              <p:cNvSpPr/>
              <p:nvPr/>
            </p:nvSpPr>
            <p:spPr>
              <a:xfrm>
                <a:off x="3224160" y="5681160"/>
                <a:ext cx="497160" cy="273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testis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1" name=""/>
              <p:cNvSpPr/>
              <p:nvPr/>
            </p:nvSpPr>
            <p:spPr>
              <a:xfrm>
                <a:off x="2723760" y="5681160"/>
                <a:ext cx="690120" cy="273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stomach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2" name=""/>
              <p:cNvSpPr/>
              <p:nvPr/>
            </p:nvSpPr>
            <p:spPr>
              <a:xfrm>
                <a:off x="3582000" y="5681160"/>
                <a:ext cx="557280" cy="273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uterus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3" name=""/>
              <p:cNvSpPr/>
              <p:nvPr/>
            </p:nvSpPr>
            <p:spPr>
              <a:xfrm>
                <a:off x="1329840" y="5681160"/>
                <a:ext cx="386280" cy="273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kid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4" name=""/>
              <p:cNvSpPr/>
              <p:nvPr/>
            </p:nvSpPr>
            <p:spPr>
              <a:xfrm>
                <a:off x="1697400" y="5681160"/>
                <a:ext cx="456120" cy="273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lung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5" name=""/>
              <p:cNvSpPr/>
              <p:nvPr/>
            </p:nvSpPr>
            <p:spPr>
              <a:xfrm>
                <a:off x="2071080" y="5690520"/>
                <a:ext cx="490680" cy="273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heart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pic>
            <p:nvPicPr>
              <p:cNvPr id="146" name="" descr=""/>
              <p:cNvPicPr/>
              <p:nvPr/>
            </p:nvPicPr>
            <p:blipFill>
              <a:blip r:embed="rId6"/>
              <a:srcRect l="0" t="4686" r="0" b="10537"/>
              <a:stretch/>
            </p:blipFill>
            <p:spPr>
              <a:xfrm>
                <a:off x="1288800" y="6102360"/>
                <a:ext cx="3573000" cy="6886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47" name=""/>
              <p:cNvSpPr/>
              <p:nvPr/>
            </p:nvSpPr>
            <p:spPr>
              <a:xfrm>
                <a:off x="3952800" y="5681160"/>
                <a:ext cx="623880" cy="273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ovaries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8" name=""/>
              <p:cNvSpPr/>
              <p:nvPr/>
            </p:nvSpPr>
            <p:spPr>
              <a:xfrm>
                <a:off x="1374480" y="5907240"/>
                <a:ext cx="275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9" name=""/>
              <p:cNvSpPr/>
              <p:nvPr/>
            </p:nvSpPr>
            <p:spPr>
              <a:xfrm>
                <a:off x="1754280" y="5907240"/>
                <a:ext cx="275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0" name=""/>
              <p:cNvSpPr/>
              <p:nvPr/>
            </p:nvSpPr>
            <p:spPr>
              <a:xfrm>
                <a:off x="2153520" y="5907240"/>
                <a:ext cx="275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1" name=""/>
              <p:cNvSpPr/>
              <p:nvPr/>
            </p:nvSpPr>
            <p:spPr>
              <a:xfrm>
                <a:off x="2523960" y="5907240"/>
                <a:ext cx="275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2" name=""/>
              <p:cNvSpPr/>
              <p:nvPr/>
            </p:nvSpPr>
            <p:spPr>
              <a:xfrm>
                <a:off x="2913840" y="5907240"/>
                <a:ext cx="275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3" name=""/>
              <p:cNvSpPr/>
              <p:nvPr/>
            </p:nvSpPr>
            <p:spPr>
              <a:xfrm>
                <a:off x="3312720" y="5907240"/>
                <a:ext cx="275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4" name=""/>
              <p:cNvSpPr/>
              <p:nvPr/>
            </p:nvSpPr>
            <p:spPr>
              <a:xfrm>
                <a:off x="3693240" y="5907240"/>
                <a:ext cx="275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5" name=""/>
              <p:cNvSpPr/>
              <p:nvPr/>
            </p:nvSpPr>
            <p:spPr>
              <a:xfrm>
                <a:off x="4073040" y="5907240"/>
                <a:ext cx="275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6" name=""/>
              <p:cNvSpPr/>
              <p:nvPr/>
            </p:nvSpPr>
            <p:spPr>
              <a:xfrm>
                <a:off x="1288800" y="6107040"/>
                <a:ext cx="3573000" cy="68400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7" name=""/>
              <p:cNvSpPr/>
              <p:nvPr/>
            </p:nvSpPr>
            <p:spPr>
              <a:xfrm>
                <a:off x="761400" y="5516280"/>
                <a:ext cx="7444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Line 137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8" name=""/>
              <p:cNvSpPr/>
              <p:nvPr/>
            </p:nvSpPr>
            <p:spPr>
              <a:xfrm>
                <a:off x="5231520" y="1694160"/>
                <a:ext cx="590760" cy="398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controls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N      P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9" name=""/>
              <p:cNvSpPr/>
              <p:nvPr/>
            </p:nvSpPr>
            <p:spPr>
              <a:xfrm>
                <a:off x="3951000" y="3035880"/>
                <a:ext cx="590760" cy="398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controls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N      P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0" name=""/>
              <p:cNvSpPr/>
              <p:nvPr/>
            </p:nvSpPr>
            <p:spPr>
              <a:xfrm>
                <a:off x="4354920" y="5726520"/>
                <a:ext cx="590760" cy="398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controls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N    P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1" name=""/>
              <p:cNvSpPr/>
              <p:nvPr/>
            </p:nvSpPr>
            <p:spPr>
              <a:xfrm>
                <a:off x="4280400" y="4334400"/>
                <a:ext cx="590760" cy="398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controls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N    P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2" name=""/>
              <p:cNvSpPr/>
              <p:nvPr/>
            </p:nvSpPr>
            <p:spPr>
              <a:xfrm>
                <a:off x="1123920" y="4717800"/>
                <a:ext cx="151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3" name=""/>
              <p:cNvSpPr/>
              <p:nvPr/>
            </p:nvSpPr>
            <p:spPr>
              <a:xfrm>
                <a:off x="1123920" y="4865400"/>
                <a:ext cx="151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4" name=""/>
              <p:cNvSpPr/>
              <p:nvPr/>
            </p:nvSpPr>
            <p:spPr>
              <a:xfrm>
                <a:off x="1123920" y="4996800"/>
                <a:ext cx="151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5" name=""/>
              <p:cNvSpPr/>
              <p:nvPr/>
            </p:nvSpPr>
            <p:spPr>
              <a:xfrm>
                <a:off x="1123920" y="5102640"/>
                <a:ext cx="151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6" name=""/>
              <p:cNvSpPr/>
              <p:nvPr/>
            </p:nvSpPr>
            <p:spPr>
              <a:xfrm>
                <a:off x="1123920" y="6137280"/>
                <a:ext cx="151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7" name=""/>
              <p:cNvSpPr/>
              <p:nvPr/>
            </p:nvSpPr>
            <p:spPr>
              <a:xfrm>
                <a:off x="1123920" y="6276600"/>
                <a:ext cx="151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8" name=""/>
              <p:cNvSpPr/>
              <p:nvPr/>
            </p:nvSpPr>
            <p:spPr>
              <a:xfrm>
                <a:off x="1123920" y="6419160"/>
                <a:ext cx="151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9" name=""/>
              <p:cNvSpPr/>
              <p:nvPr/>
            </p:nvSpPr>
            <p:spPr>
              <a:xfrm>
                <a:off x="1123920" y="6517080"/>
                <a:ext cx="151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170" name=""/>
            <p:cNvSpPr/>
            <p:nvPr/>
          </p:nvSpPr>
          <p:spPr>
            <a:xfrm>
              <a:off x="669960" y="1415880"/>
              <a:ext cx="5526000" cy="557856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9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10-16T15:35:40Z</dcterms:created>
  <dc:creator>Joanna B. Wilson</dc:creator>
  <dc:description/>
  <dc:language>en-US</dc:language>
  <cp:lastModifiedBy>Joanna Wilson</cp:lastModifiedBy>
  <cp:lastPrinted>2006-10-24T23:40:24Z</cp:lastPrinted>
  <dcterms:modified xsi:type="dcterms:W3CDTF">2010-01-18T16:50:09Z</dcterms:modified>
  <cp:revision>74</cp:revision>
  <dc:subject/>
  <dc:title>PowerPoint Presentation</dc:title>
</cp:coreProperties>
</file>